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8.png" ContentType="image/png"/>
  <Override PartName="/ppt/media/image7.png" ContentType="image/png"/>
  <Override PartName="/ppt/media/image9.jpeg" ContentType="image/jpeg"/>
  <Override PartName="/ppt/media/image10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CD414-554E-4AB8-941A-0A5716F1B6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62266-998A-4BE9-A0A6-FFB431B1FD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44464-D21B-4709-A74D-225AAF91E8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ADA92-02CB-4C5A-9345-ACC12AD42D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EE411-B81C-4AF8-B9D2-F47589A11A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17A287-67EC-407A-A139-75FFBBF419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ACC79-1467-4B8D-A385-A8125BADC8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29484-C8D4-4268-90C6-1F52921C52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84FD0-74C6-4194-BA22-BC593ADFE6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F773B-8B36-4433-9B02-02ABA059CD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5426E-C885-4418-966E-6317C1B4B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E917B5-3113-4442-8AEB-711587988E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FAED12-DEFE-4BEA-8F88-6508B9346AED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package" Target="../embeddings/oleObject1.xlsx"/><Relationship Id="rId11" Type="http://schemas.openxmlformats.org/officeDocument/2006/relationships/image" Target="../media/image10.wmf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29480" y="-15840"/>
            <a:ext cx="107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NF-α 1ng/m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968480" y="200160"/>
            <a:ext cx="3889440" cy="83880"/>
            <a:chOff x="1968480" y="200160"/>
            <a:chExt cx="3889440" cy="83880"/>
          </a:xfrm>
        </p:grpSpPr>
        <p:sp>
          <p:nvSpPr>
            <p:cNvPr id="43" name=""/>
            <p:cNvSpPr/>
            <p:nvPr/>
          </p:nvSpPr>
          <p:spPr>
            <a:xfrm>
              <a:off x="1968480" y="200160"/>
              <a:ext cx="0" cy="8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857920" y="200160"/>
              <a:ext cx="0" cy="83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968480" y="200160"/>
              <a:ext cx="3889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"/>
          <p:cNvSpPr/>
          <p:nvPr/>
        </p:nvSpPr>
        <p:spPr>
          <a:xfrm>
            <a:off x="-92160" y="1236600"/>
            <a:ext cx="148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Arial"/>
              </a:rPr>
              <a:t>Phospho-JN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5400" y="1596960"/>
            <a:ext cx="126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otal-JN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38040" y="1955880"/>
            <a:ext cx="981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9215600">
            <a:off x="1845000" y="804600"/>
            <a:ext cx="57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h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9003800">
            <a:off x="1340280" y="686880"/>
            <a:ext cx="936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9202400">
            <a:off x="2276640" y="775800"/>
            <a:ext cx="72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h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9210800">
            <a:off x="2779920" y="804600"/>
            <a:ext cx="649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h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9210800">
            <a:off x="3213360" y="804600"/>
            <a:ext cx="649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8h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9210800">
            <a:off x="3571920" y="415440"/>
            <a:ext cx="1835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Arial"/>
              </a:rPr>
              <a:t>6hr +JNKsiR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9206600">
            <a:off x="4077000" y="343800"/>
            <a:ext cx="2089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Arial"/>
              </a:rPr>
              <a:t>6hr +control siR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9202400">
            <a:off x="4592520" y="488520"/>
            <a:ext cx="157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hr + SP6001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9202400">
            <a:off x="5054760" y="488520"/>
            <a:ext cx="1687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Arial"/>
              </a:rPr>
              <a:t>6hr +Atorvaststi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9202400">
            <a:off x="5464440" y="371160"/>
            <a:ext cx="2068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6hr + Rac1 inhibito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-92160" y="2316240"/>
            <a:ext cx="148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100" spc="-1" strike="noStrike">
                <a:solidFill>
                  <a:srgbClr val="000000"/>
                </a:solidFill>
                <a:latin typeface="Arial"/>
              </a:rPr>
              <a:t>Phospho-ER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15920" y="2720880"/>
            <a:ext cx="126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otal-ER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60360" y="3108240"/>
            <a:ext cx="981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-120600" y="3513240"/>
            <a:ext cx="148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hospho-P3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95400" y="3873600"/>
            <a:ext cx="126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Total-P3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60360" y="4332240"/>
            <a:ext cx="981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1">
            <a:lum bright="6000"/>
          </a:blip>
          <a:stretch/>
        </p:blipFill>
        <p:spPr>
          <a:xfrm>
            <a:off x="1319040" y="3903840"/>
            <a:ext cx="4753080" cy="3283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rcRect l="1442" t="0" r="0" b="0"/>
          <a:stretch/>
        </p:blipFill>
        <p:spPr>
          <a:xfrm>
            <a:off x="1353960" y="4295880"/>
            <a:ext cx="4718160" cy="3697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rcRect l="1556" t="0" r="1556" b="-8028"/>
          <a:stretch/>
        </p:blipFill>
        <p:spPr>
          <a:xfrm>
            <a:off x="1353960" y="2673360"/>
            <a:ext cx="4681800" cy="33480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4">
            <a:lum bright="18000"/>
          </a:blip>
          <a:stretch/>
        </p:blipFill>
        <p:spPr>
          <a:xfrm>
            <a:off x="1353960" y="3549600"/>
            <a:ext cx="4681800" cy="32400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5"/>
          <a:srcRect l="2863" t="0" r="5704" b="3974"/>
          <a:stretch/>
        </p:blipFill>
        <p:spPr>
          <a:xfrm>
            <a:off x="1353960" y="3035160"/>
            <a:ext cx="4681800" cy="33336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6"/>
          <a:srcRect l="4492" t="0" r="4253" b="7202"/>
          <a:stretch/>
        </p:blipFill>
        <p:spPr>
          <a:xfrm>
            <a:off x="1353960" y="2344680"/>
            <a:ext cx="4680000" cy="30492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7"/>
          <a:srcRect l="1534" t="-265" r="0" b="0"/>
          <a:stretch/>
        </p:blipFill>
        <p:spPr>
          <a:xfrm>
            <a:off x="1319040" y="1913040"/>
            <a:ext cx="4846680" cy="28872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8"/>
          <a:srcRect l="4540" t="0" r="5906" b="18045"/>
          <a:stretch/>
        </p:blipFill>
        <p:spPr>
          <a:xfrm>
            <a:off x="1319040" y="1569960"/>
            <a:ext cx="4773960" cy="28728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9">
            <a:lum bright="12000"/>
          </a:blip>
          <a:srcRect l="5961" t="0" r="4476" b="-12279"/>
          <a:stretch/>
        </p:blipFill>
        <p:spPr>
          <a:xfrm>
            <a:off x="1319040" y="1157400"/>
            <a:ext cx="4753080" cy="4111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74" name=""/>
          <p:cNvGraphicFramePr/>
          <p:nvPr/>
        </p:nvGraphicFramePr>
        <p:xfrm>
          <a:off x="863640" y="4792680"/>
          <a:ext cx="5805360" cy="3311640"/>
        </p:xfrm>
        <a:graphic>
          <a:graphicData uri="http://schemas.openxmlformats.org/presentationml/2006/ole">
            <p:oleObj progId="Excel.Sheet.12" r:id="rId10" spid="">
              <p:embed/>
              <p:pic>
                <p:nvPicPr>
                  <p:cNvPr id="75" name="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863640" y="4792680"/>
                    <a:ext cx="5805360" cy="3311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6" name=""/>
          <p:cNvSpPr/>
          <p:nvPr/>
        </p:nvSpPr>
        <p:spPr>
          <a:xfrm rot="16200000">
            <a:off x="-781200" y="6285240"/>
            <a:ext cx="264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otein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evel (fold of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9365000">
            <a:off x="1413360" y="7961040"/>
            <a:ext cx="576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2h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19486800">
            <a:off x="549720" y="8089560"/>
            <a:ext cx="936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9202400">
            <a:off x="1910160" y="80164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4h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9210800">
            <a:off x="2486520" y="8016120"/>
            <a:ext cx="649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6h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9210800">
            <a:off x="3061080" y="7961040"/>
            <a:ext cx="6494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18h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9210800">
            <a:off x="2522880" y="8376840"/>
            <a:ext cx="1835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6hr</a:t>
            </a:r>
            <a:r>
              <a:rPr b="0" lang="zh-TW" sz="1300" spc="-1" strike="noStrike">
                <a:solidFill>
                  <a:srgbClr val="000000"/>
                </a:solidFill>
                <a:latin typeface="Arial"/>
              </a:rPr>
              <a:t> +</a:t>
            </a: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JNKsiRN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9206600">
            <a:off x="2853000" y="8478000"/>
            <a:ext cx="2089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6hr</a:t>
            </a:r>
            <a:r>
              <a:rPr b="0" lang="zh-TW" sz="1300" spc="-1" strike="noStrike">
                <a:solidFill>
                  <a:srgbClr val="000000"/>
                </a:solidFill>
                <a:latin typeface="Arial"/>
              </a:rPr>
              <a:t> +</a:t>
            </a: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control siRNA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19202400">
            <a:off x="3861000" y="8265240"/>
            <a:ext cx="1573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6hr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+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SP60012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19202400">
            <a:off x="4293000" y="8305560"/>
            <a:ext cx="16873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6hr</a:t>
            </a:r>
            <a:r>
              <a:rPr b="0" lang="zh-TW" sz="1300" spc="-1" strike="noStrike">
                <a:solidFill>
                  <a:srgbClr val="000000"/>
                </a:solidFill>
                <a:latin typeface="Arial"/>
              </a:rPr>
              <a:t> +</a:t>
            </a:r>
            <a:r>
              <a:rPr b="1" lang="zh-TW" sz="1300" spc="-1" strike="noStrike">
                <a:solidFill>
                  <a:srgbClr val="000000"/>
                </a:solidFill>
                <a:latin typeface="Arial"/>
              </a:rPr>
              <a:t>Atorvaststin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448440" y="9196560"/>
            <a:ext cx="1232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TNF-α</a:t>
            </a: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1ng/m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771560" y="90406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380280" y="904068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771560" y="9185400"/>
            <a:ext cx="460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9202400">
            <a:off x="4437360" y="8448480"/>
            <a:ext cx="2068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6hr + Rac1 inhibito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771840" y="7683480"/>
            <a:ext cx="272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765000" y="66643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765000" y="57117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765000" y="4792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5" name=""/>
          <p:cNvGrpSpPr/>
          <p:nvPr/>
        </p:nvGrpSpPr>
        <p:grpSpPr>
          <a:xfrm>
            <a:off x="5040360" y="4792680"/>
            <a:ext cx="1628280" cy="705960"/>
            <a:chOff x="5040360" y="4792680"/>
            <a:chExt cx="1628280" cy="705960"/>
          </a:xfrm>
        </p:grpSpPr>
        <p:sp>
          <p:nvSpPr>
            <p:cNvPr id="96" name=""/>
            <p:cNvSpPr/>
            <p:nvPr/>
          </p:nvSpPr>
          <p:spPr>
            <a:xfrm>
              <a:off x="5040360" y="4842000"/>
              <a:ext cx="178920" cy="179280"/>
            </a:xfrm>
            <a:prstGeom prst="rect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040360" y="5057640"/>
              <a:ext cx="178920" cy="179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040360" y="5273640"/>
              <a:ext cx="178920" cy="179280"/>
            </a:xfrm>
            <a:prstGeom prst="rect">
              <a:avLst/>
            </a:prstGeom>
            <a:solidFill>
              <a:srgbClr val="3333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184360" y="4792680"/>
              <a:ext cx="148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TW" sz="1100" spc="-1" strike="noStrike">
                  <a:solidFill>
                    <a:srgbClr val="000000"/>
                  </a:solidFill>
                  <a:latin typeface="Arial"/>
                </a:rPr>
                <a:t>Phospho-JNK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184360" y="5021280"/>
              <a:ext cx="148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TW" sz="1100" spc="-1" strike="noStrike">
                  <a:solidFill>
                    <a:srgbClr val="000000"/>
                  </a:solidFill>
                  <a:latin typeface="Arial"/>
                </a:rPr>
                <a:t>Phospho-ERK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184360" y="5237280"/>
              <a:ext cx="148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Phospho-P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"/>
          <p:cNvSpPr/>
          <p:nvPr/>
        </p:nvSpPr>
        <p:spPr>
          <a:xfrm>
            <a:off x="2278080" y="9489960"/>
            <a:ext cx="295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.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15920" y="344520"/>
            <a:ext cx="719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15920" y="4808520"/>
            <a:ext cx="719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517760" y="550404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708200" y="603252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060640" y="545796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602080" y="480852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141720" y="5384880"/>
            <a:ext cx="431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24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753000" y="6821640"/>
            <a:ext cx="43164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832280" y="6608880"/>
            <a:ext cx="43200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394240" y="6176880"/>
            <a:ext cx="43200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5925960" y="6824520"/>
            <a:ext cx="43200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192720" y="7182000"/>
            <a:ext cx="432000" cy="22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07T05:30:02Z</dcterms:created>
  <dc:creator>tain</dc:creator>
  <dc:description/>
  <dc:language>en-US</dc:language>
  <cp:lastModifiedBy>user</cp:lastModifiedBy>
  <dcterms:modified xsi:type="dcterms:W3CDTF">2009-03-03T11:11:58Z</dcterms:modified>
  <cp:revision>196</cp:revision>
  <dc:subject/>
  <dc:title>投影片 1</dc:title>
</cp:coreProperties>
</file>